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5705"/>
    <p:restoredTop sz="94694"/>
  </p:normalViewPr>
  <p:slideViewPr>
    <p:cSldViewPr snapToGrid="0" snapToObjects="1">
      <p:cViewPr varScale="1">
        <p:scale>
          <a:sx n="119" d="100"/>
          <a:sy n="119" d="100"/>
        </p:scale>
        <p:origin x="208" y="2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6DB0DE-136C-D849-B34A-FAE7A04F81D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F1D35F0-5458-4445-8B5D-50A3B7A4AA6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D157ACC-7C00-0342-8131-523DCE1423C5}"/>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5" name="Footer Placeholder 4">
            <a:extLst>
              <a:ext uri="{FF2B5EF4-FFF2-40B4-BE49-F238E27FC236}">
                <a16:creationId xmlns:a16="http://schemas.microsoft.com/office/drawing/2014/main" id="{2DE54515-2BAF-1748-8434-E5AC5D1643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05A233A-812C-274F-82EC-0293BF7079FB}"/>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41883446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72F489-88D0-984D-AB87-7BDEDBA32B4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0D1BD7A-92FB-A84A-AB9E-DB6CFA127FC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50F5078-2694-0048-9D7D-94F425E3812B}"/>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5" name="Footer Placeholder 4">
            <a:extLst>
              <a:ext uri="{FF2B5EF4-FFF2-40B4-BE49-F238E27FC236}">
                <a16:creationId xmlns:a16="http://schemas.microsoft.com/office/drawing/2014/main" id="{39E2C5C8-9B05-0840-A40E-32D5E2FB8FC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70B3062-B653-6642-B9A6-F70BC9E117A9}"/>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16380551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27B5857-FD34-7F40-8AE7-80D5BA25F5D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FFAC516-D480-0B44-ACF3-1DE614753BA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E0ADE0F-582A-7549-B308-4270F399B5B0}"/>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5" name="Footer Placeholder 4">
            <a:extLst>
              <a:ext uri="{FF2B5EF4-FFF2-40B4-BE49-F238E27FC236}">
                <a16:creationId xmlns:a16="http://schemas.microsoft.com/office/drawing/2014/main" id="{EA830164-B05E-094F-B435-6F29D96F7CA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6BDF6D-F026-404A-82DC-52838733DB31}"/>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16132866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7266CA-34F4-D64D-8322-A6A0DB4CE68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3B10A4A-0AC9-0640-B6D2-1B1FF53C351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2DA9E87-2B37-E547-92B1-4BAB4FC1911F}"/>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5" name="Footer Placeholder 4">
            <a:extLst>
              <a:ext uri="{FF2B5EF4-FFF2-40B4-BE49-F238E27FC236}">
                <a16:creationId xmlns:a16="http://schemas.microsoft.com/office/drawing/2014/main" id="{9F1C5F8A-54CC-8941-86CF-A81A25B34BD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B427A6-D3EF-6C4B-9049-A15E6046ED09}"/>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386507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EAC3F8-9415-E041-9582-AB83717EF15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7601CAD-ABC8-7D4B-B2C0-309713B555C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73237E5-19A3-0640-9268-2BE80112E65A}"/>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5" name="Footer Placeholder 4">
            <a:extLst>
              <a:ext uri="{FF2B5EF4-FFF2-40B4-BE49-F238E27FC236}">
                <a16:creationId xmlns:a16="http://schemas.microsoft.com/office/drawing/2014/main" id="{4C835527-497A-2E4F-86BA-4339A9531DD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E67ED25-6145-794B-80EF-CF3C1591E19B}"/>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21205015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600669-369E-5D40-9FCE-8AB237F4DA7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E204377-C0F1-E846-BE72-03D7EF41D29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0170C85-EDD2-9844-AAB4-64F68380D98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0B75EA8-5FE3-C649-A135-6DC34D8D9145}"/>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6" name="Footer Placeholder 5">
            <a:extLst>
              <a:ext uri="{FF2B5EF4-FFF2-40B4-BE49-F238E27FC236}">
                <a16:creationId xmlns:a16="http://schemas.microsoft.com/office/drawing/2014/main" id="{CE59D354-F871-4E44-A03A-9EDECBB623E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D70BAD-2C6E-7A43-887B-D9F3525D4AC3}"/>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857216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D135D7-C111-CD4F-AAB7-F0D2EEAC5B1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DC3CA88-F8D0-9B4B-9F95-A83084EEB24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0D3D898-25CE-1647-9E5C-79E828857E7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5EF22E9-624B-6F41-BB4A-CE4AB1C9873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B0A3917-443D-2747-9F1B-E21D2727C49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BC0C255-0219-B146-9732-10AF2BAC80AF}"/>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8" name="Footer Placeholder 7">
            <a:extLst>
              <a:ext uri="{FF2B5EF4-FFF2-40B4-BE49-F238E27FC236}">
                <a16:creationId xmlns:a16="http://schemas.microsoft.com/office/drawing/2014/main" id="{EEB6399F-5F12-A24F-9999-1D10198115A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23E66D3-B406-0441-B095-49A6FB5DF0EA}"/>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29913372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84EBBC-C8B8-4049-9259-3034FEFE129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FB83658-EE97-9140-9702-9B2A59D674D0}"/>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4" name="Footer Placeholder 3">
            <a:extLst>
              <a:ext uri="{FF2B5EF4-FFF2-40B4-BE49-F238E27FC236}">
                <a16:creationId xmlns:a16="http://schemas.microsoft.com/office/drawing/2014/main" id="{19992DC4-0795-3D42-A565-8219ABECFCF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8DD58E9-5205-9446-8D32-F8AA5357AC8C}"/>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34835490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5C689F5-6E89-4C4E-92D5-A7FF684FAF9C}"/>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3" name="Footer Placeholder 2">
            <a:extLst>
              <a:ext uri="{FF2B5EF4-FFF2-40B4-BE49-F238E27FC236}">
                <a16:creationId xmlns:a16="http://schemas.microsoft.com/office/drawing/2014/main" id="{F088C099-A1E6-B146-9093-8F54CD68766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7B2FA5C-AFEB-D14D-803F-216BFFAE7E3B}"/>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26778738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99FA32-5699-0647-83FF-5EBF663114A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5389775-1221-BB4F-A036-302951BFE1D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E2788F3-A02A-A445-A775-E3A593B0E04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4F37EC6-5A48-3940-869A-8FB483E1E30E}"/>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6" name="Footer Placeholder 5">
            <a:extLst>
              <a:ext uri="{FF2B5EF4-FFF2-40B4-BE49-F238E27FC236}">
                <a16:creationId xmlns:a16="http://schemas.microsoft.com/office/drawing/2014/main" id="{241AAE19-56DD-194D-BB9F-2154AA956CF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6C86F74-94A3-C642-B844-718FEA9C2F20}"/>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42286650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566222-5AE4-2645-95C6-FD14B36FAEC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E619300-16A6-A746-9804-4A4CBB6A1AB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DBC57C8-A71F-9741-8D5B-9EE4F0A9FCB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CB74486-0313-7845-AAF8-1D8179137424}"/>
              </a:ext>
            </a:extLst>
          </p:cNvPr>
          <p:cNvSpPr>
            <a:spLocks noGrp="1"/>
          </p:cNvSpPr>
          <p:nvPr>
            <p:ph type="dt" sz="half" idx="10"/>
          </p:nvPr>
        </p:nvSpPr>
        <p:spPr/>
        <p:txBody>
          <a:bodyPr/>
          <a:lstStyle/>
          <a:p>
            <a:fld id="{8F1C2875-BBE0-EB42-8436-9EF79536F231}" type="datetimeFigureOut">
              <a:rPr lang="en-US" smtClean="0"/>
              <a:t>3/3/22</a:t>
            </a:fld>
            <a:endParaRPr lang="en-US"/>
          </a:p>
        </p:txBody>
      </p:sp>
      <p:sp>
        <p:nvSpPr>
          <p:cNvPr id="6" name="Footer Placeholder 5">
            <a:extLst>
              <a:ext uri="{FF2B5EF4-FFF2-40B4-BE49-F238E27FC236}">
                <a16:creationId xmlns:a16="http://schemas.microsoft.com/office/drawing/2014/main" id="{6D2A667C-7C83-3D4C-ABA2-6F6C79F0468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304D75A-DA4A-9040-8847-998C2B821DFC}"/>
              </a:ext>
            </a:extLst>
          </p:cNvPr>
          <p:cNvSpPr>
            <a:spLocks noGrp="1"/>
          </p:cNvSpPr>
          <p:nvPr>
            <p:ph type="sldNum" sz="quarter" idx="12"/>
          </p:nvPr>
        </p:nvSpPr>
        <p:spPr/>
        <p:txBody>
          <a:bodyPr/>
          <a:lstStyle/>
          <a:p>
            <a:fld id="{0BDBD8E8-8B4C-264D-877E-BE64F69AF44A}" type="slidenum">
              <a:rPr lang="en-US" smtClean="0"/>
              <a:t>‹#›</a:t>
            </a:fld>
            <a:endParaRPr lang="en-US"/>
          </a:p>
        </p:txBody>
      </p:sp>
    </p:spTree>
    <p:extLst>
      <p:ext uri="{BB962C8B-B14F-4D97-AF65-F5344CB8AC3E}">
        <p14:creationId xmlns:p14="http://schemas.microsoft.com/office/powerpoint/2010/main" val="37481222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1C61AD6-C9B1-0648-A514-D9E6C008188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5FA4FF1-4E7F-2E43-8724-0D178CE0E54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C368F35-9EBB-C64A-8C6D-B9C1A18778B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F1C2875-BBE0-EB42-8436-9EF79536F231}" type="datetimeFigureOut">
              <a:rPr lang="en-US" smtClean="0"/>
              <a:t>3/3/22</a:t>
            </a:fld>
            <a:endParaRPr lang="en-US"/>
          </a:p>
        </p:txBody>
      </p:sp>
      <p:sp>
        <p:nvSpPr>
          <p:cNvPr id="5" name="Footer Placeholder 4">
            <a:extLst>
              <a:ext uri="{FF2B5EF4-FFF2-40B4-BE49-F238E27FC236}">
                <a16:creationId xmlns:a16="http://schemas.microsoft.com/office/drawing/2014/main" id="{46DE0C7D-A0D2-BB43-9F16-9FB57112B33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876A827-22CE-9249-A547-DFCC388E840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BDBD8E8-8B4C-264D-877E-BE64F69AF44A}" type="slidenum">
              <a:rPr lang="en-US" smtClean="0"/>
              <a:t>‹#›</a:t>
            </a:fld>
            <a:endParaRPr lang="en-US"/>
          </a:p>
        </p:txBody>
      </p:sp>
    </p:spTree>
    <p:extLst>
      <p:ext uri="{BB962C8B-B14F-4D97-AF65-F5344CB8AC3E}">
        <p14:creationId xmlns:p14="http://schemas.microsoft.com/office/powerpoint/2010/main" val="27401856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6E58206-E9C2-2447-8682-7B78C206A2D9}"/>
              </a:ext>
            </a:extLst>
          </p:cNvPr>
          <p:cNvPicPr>
            <a:picLocks noChangeAspect="1"/>
          </p:cNvPicPr>
          <p:nvPr/>
        </p:nvPicPr>
        <p:blipFill>
          <a:blip r:embed="rId2"/>
          <a:stretch>
            <a:fillRect/>
          </a:stretch>
        </p:blipFill>
        <p:spPr>
          <a:xfrm>
            <a:off x="2494043" y="0"/>
            <a:ext cx="7327843" cy="5604734"/>
          </a:xfrm>
          <a:prstGeom prst="rect">
            <a:avLst/>
          </a:prstGeom>
        </p:spPr>
      </p:pic>
      <p:sp>
        <p:nvSpPr>
          <p:cNvPr id="3" name="TextBox 2">
            <a:extLst>
              <a:ext uri="{FF2B5EF4-FFF2-40B4-BE49-F238E27FC236}">
                <a16:creationId xmlns:a16="http://schemas.microsoft.com/office/drawing/2014/main" id="{166C017B-1563-C64D-9BC3-A3EC889419D9}"/>
              </a:ext>
            </a:extLst>
          </p:cNvPr>
          <p:cNvSpPr txBox="1"/>
          <p:nvPr/>
        </p:nvSpPr>
        <p:spPr>
          <a:xfrm>
            <a:off x="233082" y="5509945"/>
            <a:ext cx="11725836" cy="1200329"/>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The y-axis shows the cluster sizes generated by clustering tools listed on the x-axis compared to the expected reference cluster sizes produced by </a:t>
            </a:r>
            <a:r>
              <a:rPr lang="en-US" dirty="0" err="1">
                <a:latin typeface="Times New Roman" panose="02020603050405020304" pitchFamily="18" charset="0"/>
                <a:cs typeface="Times New Roman" panose="02020603050405020304" pitchFamily="18" charset="0"/>
              </a:rPr>
              <a:t>PaSS</a:t>
            </a:r>
            <a:r>
              <a:rPr lang="en-US" dirty="0">
                <a:latin typeface="Times New Roman" panose="02020603050405020304" pitchFamily="18" charset="0"/>
                <a:cs typeface="Times New Roman" panose="02020603050405020304" pitchFamily="18" charset="0"/>
              </a:rPr>
              <a:t> simulations at increasingly more difficult parameters. A) 4 reference clusters of 125 sequences each. B) 5 reference clusters of 100 sequences each. C) 10 reference clusters of 50 sequences each. D) 20 reference clusters of 25 sequences each. E) 25 reference clusters of 20 sequences each. F) 50 reference clusters of 10 sequences each. </a:t>
            </a:r>
          </a:p>
        </p:txBody>
      </p:sp>
      <p:sp>
        <p:nvSpPr>
          <p:cNvPr id="4" name="TextBox 3">
            <a:extLst>
              <a:ext uri="{FF2B5EF4-FFF2-40B4-BE49-F238E27FC236}">
                <a16:creationId xmlns:a16="http://schemas.microsoft.com/office/drawing/2014/main" id="{2624DCC8-946B-3F45-8578-058D96DB73C5}"/>
              </a:ext>
            </a:extLst>
          </p:cNvPr>
          <p:cNvSpPr txBox="1"/>
          <p:nvPr/>
        </p:nvSpPr>
        <p:spPr>
          <a:xfrm>
            <a:off x="460182" y="147726"/>
            <a:ext cx="2020105" cy="400110"/>
          </a:xfrm>
          <a:prstGeom prst="rect">
            <a:avLst/>
          </a:prstGeom>
          <a:noFill/>
        </p:spPr>
        <p:txBody>
          <a:bodyPr wrap="none" rtlCol="0">
            <a:spAutoFit/>
          </a:bodyPr>
          <a:lstStyle/>
          <a:p>
            <a:r>
              <a:rPr lang="en-US" sz="2000" b="1" dirty="0">
                <a:latin typeface="Times New Roman" panose="02020603050405020304" pitchFamily="18" charset="0"/>
                <a:cs typeface="Times New Roman" panose="02020603050405020304" pitchFamily="18" charset="0"/>
              </a:rPr>
              <a:t>Additional File 7</a:t>
            </a:r>
          </a:p>
        </p:txBody>
      </p:sp>
    </p:spTree>
    <p:extLst>
      <p:ext uri="{BB962C8B-B14F-4D97-AF65-F5344CB8AC3E}">
        <p14:creationId xmlns:p14="http://schemas.microsoft.com/office/powerpoint/2010/main" val="10836724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94</Words>
  <Application>Microsoft Macintosh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gan, Robert</dc:creator>
  <cp:lastModifiedBy>Robert Logan</cp:lastModifiedBy>
  <cp:revision>3</cp:revision>
  <dcterms:created xsi:type="dcterms:W3CDTF">2022-02-20T22:27:58Z</dcterms:created>
  <dcterms:modified xsi:type="dcterms:W3CDTF">2022-03-03T20:39:11Z</dcterms:modified>
</cp:coreProperties>
</file>